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3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9AC85614-102D-4CA9-9450-A8BE79E35DBC}">
          <p14:sldIdLst>
            <p14:sldId id="263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BE600"/>
    <a:srgbClr val="CC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8271" autoAdjust="0"/>
  </p:normalViewPr>
  <p:slideViewPr>
    <p:cSldViewPr>
      <p:cViewPr>
        <p:scale>
          <a:sx n="150" d="100"/>
          <a:sy n="150" d="100"/>
        </p:scale>
        <p:origin x="-832" y="9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ome-srv-007\homes-007\azse04\My%20Documents\Results\Struvite%20files\pHs\pHs%20fina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ome-srv-007\homes-007\azse04\My%20Documents\Results\Struvite%20files\pHs\pHs%20final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home-srv-007\homes-007\azse04\My%20Documents\Results\Struvite%20files\pHs\pHs%20final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home-srv-007\homes-007\azse04\My%20Documents\Results\Struvite%20files\pHs\pHs%20final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home-srv-007\homes-007\azse04\My%20Documents\Results\Struvite%20files\pHs\pHs%20final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home-srv-007\homes-007\azse04\My%20Documents\Results\Struvite%20files\pHs\pHs%20fina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9727529844397"/>
          <c:y val="0.0904631964968661"/>
          <c:w val="0.639043659827424"/>
          <c:h val="0.591533737014465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</c:marker>
          <c:xVal>
            <c:numRef>
              <c:f>'Varied starting concs'!$AA$183:$AA$197</c:f>
              <c:numCache>
                <c:formatCode>0.00E+00</c:formatCode>
                <c:ptCount val="15"/>
                <c:pt idx="0">
                  <c:v>0.1</c:v>
                </c:pt>
                <c:pt idx="1">
                  <c:v>0.1</c:v>
                </c:pt>
                <c:pt idx="2">
                  <c:v>0.1</c:v>
                </c:pt>
                <c:pt idx="3" formatCode="General">
                  <c:v>1.0</c:v>
                </c:pt>
                <c:pt idx="4" formatCode="General">
                  <c:v>1.0</c:v>
                </c:pt>
                <c:pt idx="5" formatCode="General">
                  <c:v>1.0</c:v>
                </c:pt>
                <c:pt idx="6" formatCode="0.00">
                  <c:v>10.0</c:v>
                </c:pt>
                <c:pt idx="7" formatCode="0.00">
                  <c:v>10.0</c:v>
                </c:pt>
                <c:pt idx="8" formatCode="0.00">
                  <c:v>10.0</c:v>
                </c:pt>
                <c:pt idx="9" formatCode="0.00">
                  <c:v>100.0</c:v>
                </c:pt>
                <c:pt idx="10" formatCode="0.00">
                  <c:v>100.0</c:v>
                </c:pt>
                <c:pt idx="11" formatCode="0.00">
                  <c:v>100.0</c:v>
                </c:pt>
                <c:pt idx="12" formatCode="0.00">
                  <c:v>1000.0</c:v>
                </c:pt>
                <c:pt idx="13" formatCode="0.00">
                  <c:v>1000.0</c:v>
                </c:pt>
                <c:pt idx="14" formatCode="0.00">
                  <c:v>1000.0</c:v>
                </c:pt>
              </c:numCache>
            </c:numRef>
          </c:xVal>
          <c:yVal>
            <c:numRef>
              <c:f>'Varied starting concs'!$AC$183:$AC$197</c:f>
              <c:numCache>
                <c:formatCode>0.00</c:formatCode>
                <c:ptCount val="15"/>
                <c:pt idx="0">
                  <c:v>1.247</c:v>
                </c:pt>
                <c:pt idx="1">
                  <c:v>1.249</c:v>
                </c:pt>
                <c:pt idx="2">
                  <c:v>1.256</c:v>
                </c:pt>
                <c:pt idx="3">
                  <c:v>1.277</c:v>
                </c:pt>
                <c:pt idx="4">
                  <c:v>1.264</c:v>
                </c:pt>
                <c:pt idx="5">
                  <c:v>1.313</c:v>
                </c:pt>
                <c:pt idx="6">
                  <c:v>1.293</c:v>
                </c:pt>
                <c:pt idx="7">
                  <c:v>1.25</c:v>
                </c:pt>
                <c:pt idx="8">
                  <c:v>1.456</c:v>
                </c:pt>
                <c:pt idx="9">
                  <c:v>1.283</c:v>
                </c:pt>
                <c:pt idx="10">
                  <c:v>1.308</c:v>
                </c:pt>
                <c:pt idx="11">
                  <c:v>1.553</c:v>
                </c:pt>
                <c:pt idx="12">
                  <c:v>1.257</c:v>
                </c:pt>
                <c:pt idx="13">
                  <c:v>1.178</c:v>
                </c:pt>
                <c:pt idx="14">
                  <c:v>1.2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3063608"/>
        <c:axId val="-2112974136"/>
      </c:scatterChart>
      <c:valAx>
        <c:axId val="-2103063608"/>
        <c:scaling>
          <c:logBase val="10.0"/>
          <c:orientation val="minMax"/>
          <c:max val="1000.0"/>
          <c:min val="0.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dirty="0"/>
                  <a:t>Initial [Mg] </a:t>
                </a:r>
                <a:r>
                  <a:rPr lang="en-GB" dirty="0" smtClean="0"/>
                  <a:t>(</a:t>
                </a:r>
                <a:r>
                  <a:rPr lang="en-GB" sz="900" b="1" i="0" u="none" strike="noStrike" baseline="0" dirty="0" smtClean="0">
                    <a:effectLst/>
                  </a:rPr>
                  <a:t>µ</a:t>
                </a:r>
                <a:r>
                  <a:rPr lang="en-GB" dirty="0" smtClean="0"/>
                  <a:t>M</a:t>
                </a:r>
                <a:r>
                  <a:rPr lang="en-GB" dirty="0"/>
                  <a:t>)</a:t>
                </a:r>
              </a:p>
            </c:rich>
          </c:tx>
          <c:layout>
            <c:manualLayout>
              <c:xMode val="edge"/>
              <c:yMode val="edge"/>
              <c:x val="0.359714840674231"/>
              <c:y val="0.79456722204975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12974136"/>
        <c:crosses val="autoZero"/>
        <c:crossBetween val="midCat"/>
        <c:majorUnit val="10.0"/>
      </c:valAx>
      <c:valAx>
        <c:axId val="-21129741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Equilibrium [Pi] (mM)</a:t>
                </a:r>
              </a:p>
            </c:rich>
          </c:tx>
          <c:layout>
            <c:manualLayout>
              <c:xMode val="edge"/>
              <c:yMode val="edge"/>
              <c:x val="0.0410084677291526"/>
              <c:y val="0.0708390936347507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03063608"/>
        <c:crossesAt val="0.1"/>
        <c:crossBetween val="midCat"/>
        <c:majorUnit val="0.6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6049521178748"/>
          <c:y val="0.0494597399663907"/>
          <c:w val="0.644484323605541"/>
          <c:h val="0.644027476767878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</c:marker>
          <c:xVal>
            <c:numRef>
              <c:f>'Varied starting concs'!$AA$183:$AA$197</c:f>
              <c:numCache>
                <c:formatCode>0.00E+00</c:formatCode>
                <c:ptCount val="15"/>
                <c:pt idx="0">
                  <c:v>0.1</c:v>
                </c:pt>
                <c:pt idx="1">
                  <c:v>0.1</c:v>
                </c:pt>
                <c:pt idx="2">
                  <c:v>0.1</c:v>
                </c:pt>
                <c:pt idx="3" formatCode="General">
                  <c:v>1.0</c:v>
                </c:pt>
                <c:pt idx="4" formatCode="General">
                  <c:v>1.0</c:v>
                </c:pt>
                <c:pt idx="5" formatCode="General">
                  <c:v>1.0</c:v>
                </c:pt>
                <c:pt idx="6" formatCode="0.00">
                  <c:v>10.0</c:v>
                </c:pt>
                <c:pt idx="7" formatCode="0.00">
                  <c:v>10.0</c:v>
                </c:pt>
                <c:pt idx="8" formatCode="0.00">
                  <c:v>10.0</c:v>
                </c:pt>
                <c:pt idx="9" formatCode="0.00">
                  <c:v>100.0</c:v>
                </c:pt>
                <c:pt idx="10" formatCode="0.00">
                  <c:v>100.0</c:v>
                </c:pt>
                <c:pt idx="11" formatCode="0.00">
                  <c:v>100.0</c:v>
                </c:pt>
                <c:pt idx="12" formatCode="0.00">
                  <c:v>1000.0</c:v>
                </c:pt>
                <c:pt idx="13" formatCode="0.00">
                  <c:v>1000.0</c:v>
                </c:pt>
                <c:pt idx="14" formatCode="0.00">
                  <c:v>1000.0</c:v>
                </c:pt>
              </c:numCache>
            </c:numRef>
          </c:xVal>
          <c:yVal>
            <c:numRef>
              <c:f>'Varied starting concs'!$AF$183:$AF$197</c:f>
              <c:numCache>
                <c:formatCode>0.00</c:formatCode>
                <c:ptCount val="15"/>
                <c:pt idx="0">
                  <c:v>1.247</c:v>
                </c:pt>
                <c:pt idx="1">
                  <c:v>1.249</c:v>
                </c:pt>
                <c:pt idx="2">
                  <c:v>1.256</c:v>
                </c:pt>
                <c:pt idx="6">
                  <c:v>1.172</c:v>
                </c:pt>
                <c:pt idx="7">
                  <c:v>1.236</c:v>
                </c:pt>
                <c:pt idx="8">
                  <c:v>1.168</c:v>
                </c:pt>
                <c:pt idx="9">
                  <c:v>1.119</c:v>
                </c:pt>
                <c:pt idx="10">
                  <c:v>1.105</c:v>
                </c:pt>
                <c:pt idx="11">
                  <c:v>1.165</c:v>
                </c:pt>
                <c:pt idx="12">
                  <c:v>1.066</c:v>
                </c:pt>
                <c:pt idx="13">
                  <c:v>1.084</c:v>
                </c:pt>
                <c:pt idx="14">
                  <c:v>1.08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3465880"/>
        <c:axId val="-2113886856"/>
      </c:scatterChart>
      <c:valAx>
        <c:axId val="-2113465880"/>
        <c:scaling>
          <c:logBase val="10.0"/>
          <c:orientation val="minMax"/>
          <c:max val="1000.0"/>
          <c:min val="0.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dirty="0"/>
                  <a:t>Initial [NH</a:t>
                </a:r>
                <a:r>
                  <a:rPr lang="en-GB" baseline="-25000" dirty="0"/>
                  <a:t>4</a:t>
                </a:r>
                <a:r>
                  <a:rPr lang="en-GB" dirty="0"/>
                  <a:t>] </a:t>
                </a:r>
                <a:r>
                  <a:rPr lang="en-GB" dirty="0" smtClean="0"/>
                  <a:t>(</a:t>
                </a:r>
                <a:r>
                  <a:rPr lang="en-GB" sz="900" b="1" i="0" u="none" strike="noStrike" baseline="0" dirty="0" smtClean="0">
                    <a:effectLst/>
                  </a:rPr>
                  <a:t>µ</a:t>
                </a:r>
                <a:r>
                  <a:rPr lang="en-GB" dirty="0" smtClean="0"/>
                  <a:t>M</a:t>
                </a:r>
                <a:r>
                  <a:rPr lang="en-GB" dirty="0"/>
                  <a:t>)</a:t>
                </a:r>
              </a:p>
            </c:rich>
          </c:tx>
          <c:layout>
            <c:manualLayout>
              <c:xMode val="edge"/>
              <c:yMode val="edge"/>
              <c:x val="0.370596168230465"/>
              <c:y val="0.818770944934174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13886856"/>
        <c:crosses val="autoZero"/>
        <c:crossBetween val="midCat"/>
        <c:majorUnit val="10.0"/>
      </c:valAx>
      <c:valAx>
        <c:axId val="-2113886856"/>
        <c:scaling>
          <c:orientation val="minMax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Equilibrium [Pi] (mM)</a:t>
                </a:r>
              </a:p>
            </c:rich>
          </c:tx>
          <c:layout>
            <c:manualLayout>
              <c:xMode val="edge"/>
              <c:yMode val="edge"/>
              <c:x val="0.0410084677291526"/>
              <c:y val="0.0275085726970552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13465880"/>
        <c:crossesAt val="0.1"/>
        <c:crossBetween val="midCat"/>
        <c:majorUnit val="0.6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1490184956865"/>
          <c:y val="0.082924596788794"/>
          <c:w val="0.639043659827424"/>
          <c:h val="0.599072336722537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</c:marker>
          <c:xVal>
            <c:numRef>
              <c:f>'Varied starting concs'!$AA$183:$AA$197</c:f>
              <c:numCache>
                <c:formatCode>0.00E+00</c:formatCode>
                <c:ptCount val="15"/>
                <c:pt idx="0">
                  <c:v>0.1</c:v>
                </c:pt>
                <c:pt idx="1">
                  <c:v>0.1</c:v>
                </c:pt>
                <c:pt idx="2">
                  <c:v>0.1</c:v>
                </c:pt>
                <c:pt idx="3" formatCode="General">
                  <c:v>1.0</c:v>
                </c:pt>
                <c:pt idx="4" formatCode="General">
                  <c:v>1.0</c:v>
                </c:pt>
                <c:pt idx="5" formatCode="General">
                  <c:v>1.0</c:v>
                </c:pt>
                <c:pt idx="6" formatCode="0.00">
                  <c:v>10.0</c:v>
                </c:pt>
                <c:pt idx="7" formatCode="0.00">
                  <c:v>10.0</c:v>
                </c:pt>
                <c:pt idx="8" formatCode="0.00">
                  <c:v>10.0</c:v>
                </c:pt>
                <c:pt idx="9" formatCode="0.00">
                  <c:v>100.0</c:v>
                </c:pt>
                <c:pt idx="10" formatCode="0.00">
                  <c:v>100.0</c:v>
                </c:pt>
                <c:pt idx="11" formatCode="0.00">
                  <c:v>100.0</c:v>
                </c:pt>
                <c:pt idx="12" formatCode="0.00">
                  <c:v>1000.0</c:v>
                </c:pt>
                <c:pt idx="13" formatCode="0.00">
                  <c:v>1000.0</c:v>
                </c:pt>
                <c:pt idx="14" formatCode="0.00">
                  <c:v>1000.0</c:v>
                </c:pt>
              </c:numCache>
            </c:numRef>
          </c:xVal>
          <c:yVal>
            <c:numRef>
              <c:f>'Varied starting concs'!$AI$183:$AI$197</c:f>
              <c:numCache>
                <c:formatCode>0.00</c:formatCode>
                <c:ptCount val="15"/>
                <c:pt idx="0">
                  <c:v>1.247</c:v>
                </c:pt>
                <c:pt idx="1">
                  <c:v>1.249</c:v>
                </c:pt>
                <c:pt idx="2">
                  <c:v>1.256</c:v>
                </c:pt>
                <c:pt idx="3">
                  <c:v>1.208</c:v>
                </c:pt>
                <c:pt idx="4">
                  <c:v>1.24</c:v>
                </c:pt>
                <c:pt idx="5">
                  <c:v>1.295</c:v>
                </c:pt>
                <c:pt idx="6">
                  <c:v>1.204</c:v>
                </c:pt>
                <c:pt idx="7">
                  <c:v>1.275</c:v>
                </c:pt>
                <c:pt idx="8">
                  <c:v>1.246</c:v>
                </c:pt>
                <c:pt idx="9">
                  <c:v>1.063</c:v>
                </c:pt>
                <c:pt idx="10">
                  <c:v>1.241</c:v>
                </c:pt>
                <c:pt idx="11">
                  <c:v>1.07</c:v>
                </c:pt>
                <c:pt idx="12">
                  <c:v>0.2577</c:v>
                </c:pt>
                <c:pt idx="13">
                  <c:v>0.2798</c:v>
                </c:pt>
                <c:pt idx="14">
                  <c:v>0.31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2736216"/>
        <c:axId val="-2112979368"/>
      </c:scatterChart>
      <c:valAx>
        <c:axId val="-2102736216"/>
        <c:scaling>
          <c:logBase val="10.0"/>
          <c:orientation val="minMax"/>
          <c:max val="1000.0"/>
          <c:min val="0.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dirty="0"/>
                  <a:t>Initial [Pi] </a:t>
                </a:r>
                <a:r>
                  <a:rPr lang="en-GB" dirty="0" smtClean="0"/>
                  <a:t>(</a:t>
                </a:r>
                <a:r>
                  <a:rPr lang="en-GB" sz="900" b="1" i="0" u="none" strike="noStrike" baseline="0" dirty="0" smtClean="0">
                    <a:effectLst/>
                  </a:rPr>
                  <a:t>µ</a:t>
                </a:r>
                <a:r>
                  <a:rPr lang="en-GB" dirty="0" smtClean="0"/>
                  <a:t>M</a:t>
                </a:r>
                <a:r>
                  <a:rPr lang="en-GB" dirty="0"/>
                  <a:t>)</a:t>
                </a:r>
              </a:p>
            </c:rich>
          </c:tx>
          <c:layout>
            <c:manualLayout>
              <c:xMode val="edge"/>
              <c:yMode val="edge"/>
              <c:x val="0.403240150899166"/>
              <c:y val="0.79456722204975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12979368"/>
        <c:crosses val="autoZero"/>
        <c:crossBetween val="midCat"/>
        <c:majorUnit val="10.0"/>
      </c:valAx>
      <c:valAx>
        <c:axId val="-2112979368"/>
        <c:scaling>
          <c:orientation val="minMax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Equilibrium [Pi] (mM)</a:t>
                </a:r>
              </a:p>
            </c:rich>
          </c:tx>
          <c:layout>
            <c:manualLayout>
              <c:xMode val="edge"/>
              <c:yMode val="edge"/>
              <c:x val="0.0355678039510357"/>
              <c:y val="0.110645868046013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02736216"/>
        <c:crossesAt val="0.1"/>
        <c:crossBetween val="midCat"/>
        <c:majorUnit val="0.6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5967697022715"/>
          <c:y val="0.103388895486708"/>
          <c:w val="0.644566147761574"/>
          <c:h val="0.676555095410855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</c:marker>
          <c:xVal>
            <c:numRef>
              <c:f>'Varied starting concs'!$AA$183:$AA$197</c:f>
              <c:numCache>
                <c:formatCode>0.00E+00</c:formatCode>
                <c:ptCount val="15"/>
                <c:pt idx="0">
                  <c:v>0.1</c:v>
                </c:pt>
                <c:pt idx="1">
                  <c:v>0.1</c:v>
                </c:pt>
                <c:pt idx="2">
                  <c:v>0.1</c:v>
                </c:pt>
                <c:pt idx="3" formatCode="General">
                  <c:v>1.0</c:v>
                </c:pt>
                <c:pt idx="4" formatCode="General">
                  <c:v>1.0</c:v>
                </c:pt>
                <c:pt idx="5" formatCode="General">
                  <c:v>1.0</c:v>
                </c:pt>
                <c:pt idx="6" formatCode="0.00">
                  <c:v>10.0</c:v>
                </c:pt>
                <c:pt idx="7" formatCode="0.00">
                  <c:v>10.0</c:v>
                </c:pt>
                <c:pt idx="8" formatCode="0.00">
                  <c:v>10.0</c:v>
                </c:pt>
                <c:pt idx="9" formatCode="0.00">
                  <c:v>100.0</c:v>
                </c:pt>
                <c:pt idx="10" formatCode="0.00">
                  <c:v>100.0</c:v>
                </c:pt>
                <c:pt idx="11" formatCode="0.00">
                  <c:v>100.0</c:v>
                </c:pt>
                <c:pt idx="12" formatCode="0.00">
                  <c:v>1000.0</c:v>
                </c:pt>
                <c:pt idx="13" formatCode="0.00">
                  <c:v>1000.0</c:v>
                </c:pt>
                <c:pt idx="14" formatCode="0.00">
                  <c:v>1000.0</c:v>
                </c:pt>
              </c:numCache>
            </c:numRef>
          </c:xVal>
          <c:yVal>
            <c:numRef>
              <c:f>'Varied starting concs'!$AE$183:$AE$197</c:f>
              <c:numCache>
                <c:formatCode>0.00</c:formatCode>
                <c:ptCount val="15"/>
                <c:pt idx="0">
                  <c:v>0.318011548894654</c:v>
                </c:pt>
                <c:pt idx="1">
                  <c:v>0.323528257518395</c:v>
                </c:pt>
                <c:pt idx="2">
                  <c:v>0.319010725945551</c:v>
                </c:pt>
                <c:pt idx="6">
                  <c:v>0.342331567262244</c:v>
                </c:pt>
                <c:pt idx="7">
                  <c:v>0.317761024305794</c:v>
                </c:pt>
                <c:pt idx="8">
                  <c:v>0.377060504718039</c:v>
                </c:pt>
                <c:pt idx="9">
                  <c:v>0.32700057228935</c:v>
                </c:pt>
                <c:pt idx="10">
                  <c:v>0.570371419252308</c:v>
                </c:pt>
                <c:pt idx="11">
                  <c:v>0.332356964247649</c:v>
                </c:pt>
                <c:pt idx="12">
                  <c:v>0.367198716263116</c:v>
                </c:pt>
                <c:pt idx="13">
                  <c:v>0.415669586184576</c:v>
                </c:pt>
                <c:pt idx="14">
                  <c:v>0.31401559602176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3892888"/>
        <c:axId val="-2102769128"/>
      </c:scatterChart>
      <c:valAx>
        <c:axId val="-2113892888"/>
        <c:scaling>
          <c:logBase val="10.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dirty="0"/>
                  <a:t>Initial [NH</a:t>
                </a:r>
                <a:r>
                  <a:rPr lang="en-GB" baseline="-25000" dirty="0"/>
                  <a:t>4</a:t>
                </a:r>
                <a:r>
                  <a:rPr lang="en-GB" dirty="0"/>
                  <a:t>] </a:t>
                </a:r>
                <a:r>
                  <a:rPr lang="en-GB" dirty="0" smtClean="0"/>
                  <a:t>(</a:t>
                </a:r>
                <a:r>
                  <a:rPr lang="en-GB" dirty="0">
                    <a:latin typeface="Arial"/>
                    <a:cs typeface="Arial"/>
                  </a:rPr>
                  <a:t>µ</a:t>
                </a:r>
                <a:r>
                  <a:rPr lang="en-GB" dirty="0" smtClean="0"/>
                  <a:t>M</a:t>
                </a:r>
                <a:r>
                  <a:rPr lang="en-GB" dirty="0"/>
                  <a:t>)</a:t>
                </a:r>
              </a:p>
            </c:rich>
          </c:tx>
          <c:layout>
            <c:manualLayout>
              <c:xMode val="edge"/>
              <c:yMode val="edge"/>
              <c:x val="0.365155504452348"/>
              <c:y val="0.86216090932425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02769128"/>
        <c:crosses val="autoZero"/>
        <c:crossBetween val="midCat"/>
        <c:majorUnit val="10.0"/>
      </c:valAx>
      <c:valAx>
        <c:axId val="-2102769128"/>
        <c:scaling>
          <c:orientation val="minMax"/>
          <c:max val="0.6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Initial Pi dissolution rate (mM/day)</a:t>
                </a:r>
              </a:p>
            </c:rich>
          </c:tx>
          <c:layout>
            <c:manualLayout>
              <c:xMode val="edge"/>
              <c:yMode val="edge"/>
              <c:x val="0.0"/>
              <c:y val="0.153970440066046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13892888"/>
        <c:crossesAt val="0.1"/>
        <c:crossBetween val="midCat"/>
        <c:majorUnit val="0.2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8538772290452"/>
          <c:y val="0.103623411691639"/>
          <c:w val="0.601020812689825"/>
          <c:h val="0.681916922725444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</c:marker>
          <c:xVal>
            <c:numRef>
              <c:f>'Varied starting concs'!$AA$183:$AA$197</c:f>
              <c:numCache>
                <c:formatCode>0.00E+00</c:formatCode>
                <c:ptCount val="15"/>
                <c:pt idx="0">
                  <c:v>0.1</c:v>
                </c:pt>
                <c:pt idx="1">
                  <c:v>0.1</c:v>
                </c:pt>
                <c:pt idx="2">
                  <c:v>0.1</c:v>
                </c:pt>
                <c:pt idx="3" formatCode="General">
                  <c:v>1.0</c:v>
                </c:pt>
                <c:pt idx="4" formatCode="General">
                  <c:v>1.0</c:v>
                </c:pt>
                <c:pt idx="5" formatCode="General">
                  <c:v>1.0</c:v>
                </c:pt>
                <c:pt idx="6" formatCode="0.00">
                  <c:v>10.0</c:v>
                </c:pt>
                <c:pt idx="7" formatCode="0.00">
                  <c:v>10.0</c:v>
                </c:pt>
                <c:pt idx="8" formatCode="0.00">
                  <c:v>10.0</c:v>
                </c:pt>
                <c:pt idx="9" formatCode="0.00">
                  <c:v>100.0</c:v>
                </c:pt>
                <c:pt idx="10" formatCode="0.00">
                  <c:v>100.0</c:v>
                </c:pt>
                <c:pt idx="11" formatCode="0.00">
                  <c:v>100.0</c:v>
                </c:pt>
                <c:pt idx="12" formatCode="0.00">
                  <c:v>1000.0</c:v>
                </c:pt>
                <c:pt idx="13" formatCode="0.00">
                  <c:v>1000.0</c:v>
                </c:pt>
                <c:pt idx="14" formatCode="0.00">
                  <c:v>1000.0</c:v>
                </c:pt>
              </c:numCache>
            </c:numRef>
          </c:xVal>
          <c:yVal>
            <c:numRef>
              <c:f>'Varied starting concs'!$AB$183:$AB$197</c:f>
              <c:numCache>
                <c:formatCode>0.00</c:formatCode>
                <c:ptCount val="15"/>
                <c:pt idx="0">
                  <c:v>0.318011548894654</c:v>
                </c:pt>
                <c:pt idx="1">
                  <c:v>0.323528257518395</c:v>
                </c:pt>
                <c:pt idx="2">
                  <c:v>0.319010725945551</c:v>
                </c:pt>
                <c:pt idx="3">
                  <c:v>0.256696409431023</c:v>
                </c:pt>
                <c:pt idx="4">
                  <c:v>0.282843695839074</c:v>
                </c:pt>
                <c:pt idx="5">
                  <c:v>0.215861212910883</c:v>
                </c:pt>
                <c:pt idx="6">
                  <c:v>0.256124101501649</c:v>
                </c:pt>
                <c:pt idx="7">
                  <c:v>0.279398277055366</c:v>
                </c:pt>
                <c:pt idx="8">
                  <c:v>0.205110445731341</c:v>
                </c:pt>
                <c:pt idx="9">
                  <c:v>0.317953751571192</c:v>
                </c:pt>
                <c:pt idx="10">
                  <c:v>0.304852463325569</c:v>
                </c:pt>
                <c:pt idx="11">
                  <c:v>0.265418496422922</c:v>
                </c:pt>
                <c:pt idx="12">
                  <c:v>0.272659642965412</c:v>
                </c:pt>
                <c:pt idx="13">
                  <c:v>0.342035010587023</c:v>
                </c:pt>
                <c:pt idx="14">
                  <c:v>0.26828543887620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5365960"/>
        <c:axId val="-2104804296"/>
      </c:scatterChart>
      <c:valAx>
        <c:axId val="-2105365960"/>
        <c:scaling>
          <c:logBase val="10.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dirty="0"/>
                  <a:t>Initial [Mg] </a:t>
                </a:r>
                <a:r>
                  <a:rPr lang="en-GB" dirty="0" smtClean="0"/>
                  <a:t>(</a:t>
                </a:r>
                <a:r>
                  <a:rPr lang="en-GB" sz="900" b="1" i="0" u="none" strike="noStrike" baseline="0" dirty="0" smtClean="0">
                    <a:effectLst/>
                  </a:rPr>
                  <a:t>µ</a:t>
                </a:r>
                <a:r>
                  <a:rPr lang="en-GB" dirty="0" smtClean="0"/>
                  <a:t>M</a:t>
                </a:r>
                <a:r>
                  <a:rPr lang="en-GB" dirty="0"/>
                  <a:t>)</a:t>
                </a:r>
              </a:p>
            </c:rich>
          </c:tx>
          <c:layout>
            <c:manualLayout>
              <c:xMode val="edge"/>
              <c:yMode val="edge"/>
              <c:x val="0.360033682947161"/>
              <c:y val="0.87208580152876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04804296"/>
        <c:crosses val="autoZero"/>
        <c:crossBetween val="midCat"/>
        <c:majorUnit val="10.0"/>
      </c:valAx>
      <c:valAx>
        <c:axId val="-21048042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Initial Pi dissolution rate (mM/day)</a:t>
                </a:r>
              </a:p>
            </c:rich>
          </c:tx>
          <c:layout>
            <c:manualLayout>
              <c:xMode val="edge"/>
              <c:yMode val="edge"/>
              <c:x val="0.0138050881737446"/>
              <c:y val="0.129795642537147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05365960"/>
        <c:crossesAt val="0.1"/>
        <c:crossBetween val="midCat"/>
        <c:majorUnit val="0.1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3022645866879"/>
          <c:y val="0.0692879362610504"/>
          <c:w val="0.569572630238763"/>
          <c:h val="0.702796911454283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</c:marker>
          <c:xVal>
            <c:numRef>
              <c:f>'Varied starting concs'!$AA$183:$AA$197</c:f>
              <c:numCache>
                <c:formatCode>0.00E+00</c:formatCode>
                <c:ptCount val="15"/>
                <c:pt idx="0">
                  <c:v>0.1</c:v>
                </c:pt>
                <c:pt idx="1">
                  <c:v>0.1</c:v>
                </c:pt>
                <c:pt idx="2">
                  <c:v>0.1</c:v>
                </c:pt>
                <c:pt idx="3" formatCode="General">
                  <c:v>1.0</c:v>
                </c:pt>
                <c:pt idx="4" formatCode="General">
                  <c:v>1.0</c:v>
                </c:pt>
                <c:pt idx="5" formatCode="General">
                  <c:v>1.0</c:v>
                </c:pt>
                <c:pt idx="6" formatCode="0.00">
                  <c:v>10.0</c:v>
                </c:pt>
                <c:pt idx="7" formatCode="0.00">
                  <c:v>10.0</c:v>
                </c:pt>
                <c:pt idx="8" formatCode="0.00">
                  <c:v>10.0</c:v>
                </c:pt>
                <c:pt idx="9" formatCode="0.00">
                  <c:v>100.0</c:v>
                </c:pt>
                <c:pt idx="10" formatCode="0.00">
                  <c:v>100.0</c:v>
                </c:pt>
                <c:pt idx="11" formatCode="0.00">
                  <c:v>100.0</c:v>
                </c:pt>
                <c:pt idx="12" formatCode="0.00">
                  <c:v>1000.0</c:v>
                </c:pt>
                <c:pt idx="13" formatCode="0.00">
                  <c:v>1000.0</c:v>
                </c:pt>
                <c:pt idx="14" formatCode="0.00">
                  <c:v>1000.0</c:v>
                </c:pt>
              </c:numCache>
            </c:numRef>
          </c:xVal>
          <c:yVal>
            <c:numRef>
              <c:f>'Varied starting concs'!$AH$183:$AH$197</c:f>
              <c:numCache>
                <c:formatCode>0.00</c:formatCode>
                <c:ptCount val="15"/>
                <c:pt idx="0">
                  <c:v>0.318011548894654</c:v>
                </c:pt>
                <c:pt idx="1">
                  <c:v>0.323528257518395</c:v>
                </c:pt>
                <c:pt idx="2">
                  <c:v>0.319010725945551</c:v>
                </c:pt>
                <c:pt idx="3">
                  <c:v>0.248303485439216</c:v>
                </c:pt>
                <c:pt idx="4">
                  <c:v>0.236588745340998</c:v>
                </c:pt>
                <c:pt idx="5">
                  <c:v>0.239270077286397</c:v>
                </c:pt>
                <c:pt idx="6">
                  <c:v>0.261462421482541</c:v>
                </c:pt>
                <c:pt idx="7">
                  <c:v>0.306369380440205</c:v>
                </c:pt>
                <c:pt idx="8">
                  <c:v>0.256726641694526</c:v>
                </c:pt>
                <c:pt idx="9">
                  <c:v>0.313487328948762</c:v>
                </c:pt>
                <c:pt idx="10">
                  <c:v>0.181125259856022</c:v>
                </c:pt>
                <c:pt idx="11">
                  <c:v>0.583227106869203</c:v>
                </c:pt>
                <c:pt idx="12">
                  <c:v>0.051015130242414</c:v>
                </c:pt>
                <c:pt idx="13">
                  <c:v>0.0557313793006487</c:v>
                </c:pt>
                <c:pt idx="14">
                  <c:v>0.024498257871399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4805560"/>
        <c:axId val="-2105454472"/>
      </c:scatterChart>
      <c:valAx>
        <c:axId val="-2104805560"/>
        <c:scaling>
          <c:logBase val="10.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dirty="0"/>
                  <a:t>Initial [Pi] </a:t>
                </a:r>
                <a:r>
                  <a:rPr lang="en-GB" dirty="0" smtClean="0"/>
                  <a:t>(</a:t>
                </a:r>
                <a:r>
                  <a:rPr lang="en-GB" sz="900" b="1" i="0" u="none" strike="noStrike" baseline="0" dirty="0" smtClean="0">
                    <a:effectLst/>
                  </a:rPr>
                  <a:t>µ</a:t>
                </a:r>
                <a:r>
                  <a:rPr lang="en-GB" dirty="0" smtClean="0"/>
                  <a:t>M</a:t>
                </a:r>
                <a:r>
                  <a:rPr lang="en-GB" dirty="0"/>
                  <a:t>)</a:t>
                </a:r>
              </a:p>
            </c:rich>
          </c:tx>
          <c:layout>
            <c:manualLayout>
              <c:xMode val="edge"/>
              <c:yMode val="edge"/>
              <c:x val="0.382214821262492"/>
              <c:y val="0.861074959925088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05454472"/>
        <c:crosses val="autoZero"/>
        <c:crossBetween val="midCat"/>
        <c:majorUnit val="10.0"/>
      </c:valAx>
      <c:valAx>
        <c:axId val="-2105454472"/>
        <c:scaling>
          <c:orientation val="minMax"/>
          <c:max val="0.6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Initial Pi dissolution rate (mM/day)</a:t>
                </a:r>
              </a:p>
            </c:rich>
          </c:tx>
          <c:layout>
            <c:manualLayout>
              <c:xMode val="edge"/>
              <c:yMode val="edge"/>
              <c:x val="0.0332160524065389"/>
              <c:y val="0.125734045423524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104805560"/>
        <c:crossesAt val="0.1"/>
        <c:crossBetween val="midCat"/>
        <c:majorUnit val="0.2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400" cy="49688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9" y="1"/>
            <a:ext cx="2946400" cy="49688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9C0AD7-2AC2-45B6-AC42-0DB0ECA34D76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4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9" y="9428164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0078A8-8004-4915-8C4D-18CB275F8C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1859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2AD0B2-D3B6-4624-A350-450779147E81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147F85-70E4-4845-AF5D-F89FBEE36B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2500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BEA42-9BA0-44A7-8366-CEF44311893B}" type="datetimeFigureOut">
              <a:rPr lang="en-GB" smtClean="0"/>
              <a:t>16/07/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99E9DD-3D74-4F49-B945-8EA57FD9D4B0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8" name="Chart 4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9972804"/>
              </p:ext>
            </p:extLst>
          </p:nvPr>
        </p:nvGraphicFramePr>
        <p:xfrm>
          <a:off x="3138678" y="3180422"/>
          <a:ext cx="2334274" cy="1684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90" name="Chart 4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5808452"/>
              </p:ext>
            </p:extLst>
          </p:nvPr>
        </p:nvGraphicFramePr>
        <p:xfrm>
          <a:off x="834422" y="3252430"/>
          <a:ext cx="2334274" cy="15406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92" name="Chart 49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8759701"/>
              </p:ext>
            </p:extLst>
          </p:nvPr>
        </p:nvGraphicFramePr>
        <p:xfrm>
          <a:off x="5442934" y="3180422"/>
          <a:ext cx="2334274" cy="1684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91" name="Chart 49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8731260"/>
              </p:ext>
            </p:extLst>
          </p:nvPr>
        </p:nvGraphicFramePr>
        <p:xfrm>
          <a:off x="834422" y="1043788"/>
          <a:ext cx="2334274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89" name="Chart 48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9873208"/>
              </p:ext>
            </p:extLst>
          </p:nvPr>
        </p:nvGraphicFramePr>
        <p:xfrm>
          <a:off x="3066670" y="1034263"/>
          <a:ext cx="2479593" cy="20835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93" name="Chart 4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9269980"/>
              </p:ext>
            </p:extLst>
          </p:nvPr>
        </p:nvGraphicFramePr>
        <p:xfrm>
          <a:off x="5370926" y="1115797"/>
          <a:ext cx="2617078" cy="20162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410486" y="1183041"/>
            <a:ext cx="1080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i="1" dirty="0"/>
              <a:t>r</a:t>
            </a:r>
            <a:r>
              <a:rPr lang="el-GR" sz="900" dirty="0" smtClean="0"/>
              <a:t> </a:t>
            </a:r>
            <a:r>
              <a:rPr lang="en-GB" sz="900" dirty="0" smtClean="0"/>
              <a:t>= 0.09</a:t>
            </a:r>
            <a:endParaRPr lang="en-GB" sz="900" dirty="0"/>
          </a:p>
        </p:txBody>
      </p:sp>
      <p:sp>
        <p:nvSpPr>
          <p:cNvPr id="494" name="TextBox 493"/>
          <p:cNvSpPr txBox="1"/>
          <p:nvPr/>
        </p:nvSpPr>
        <p:spPr>
          <a:xfrm>
            <a:off x="1386951" y="3252430"/>
            <a:ext cx="1080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i="1" dirty="0"/>
              <a:t>r</a:t>
            </a:r>
            <a:r>
              <a:rPr lang="el-GR" sz="900" dirty="0" smtClean="0"/>
              <a:t> </a:t>
            </a:r>
            <a:r>
              <a:rPr lang="en-GB" sz="900" dirty="0" smtClean="0"/>
              <a:t>= -0.76</a:t>
            </a:r>
            <a:endParaRPr lang="en-GB" sz="900" dirty="0"/>
          </a:p>
        </p:txBody>
      </p:sp>
      <p:sp>
        <p:nvSpPr>
          <p:cNvPr id="495" name="TextBox 494"/>
          <p:cNvSpPr txBox="1"/>
          <p:nvPr/>
        </p:nvSpPr>
        <p:spPr>
          <a:xfrm>
            <a:off x="3653367" y="3252430"/>
            <a:ext cx="1080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i="1" dirty="0"/>
              <a:t>r</a:t>
            </a:r>
            <a:r>
              <a:rPr lang="el-GR" sz="900" dirty="0" smtClean="0"/>
              <a:t> </a:t>
            </a:r>
            <a:r>
              <a:rPr lang="en-GB" sz="900" dirty="0" smtClean="0"/>
              <a:t>= -0.26</a:t>
            </a:r>
            <a:endParaRPr lang="en-GB" sz="900" dirty="0"/>
          </a:p>
        </p:txBody>
      </p:sp>
      <p:sp>
        <p:nvSpPr>
          <p:cNvPr id="496" name="TextBox 495"/>
          <p:cNvSpPr txBox="1"/>
          <p:nvPr/>
        </p:nvSpPr>
        <p:spPr>
          <a:xfrm>
            <a:off x="3653367" y="1183041"/>
            <a:ext cx="1080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i="1" dirty="0"/>
              <a:t>r</a:t>
            </a:r>
            <a:r>
              <a:rPr lang="el-GR" sz="900" dirty="0" smtClean="0"/>
              <a:t> </a:t>
            </a:r>
            <a:r>
              <a:rPr lang="en-GB" sz="900" dirty="0" smtClean="0"/>
              <a:t>= 0.18</a:t>
            </a:r>
            <a:endParaRPr lang="en-GB" sz="900" dirty="0"/>
          </a:p>
        </p:txBody>
      </p:sp>
      <p:sp>
        <p:nvSpPr>
          <p:cNvPr id="497" name="TextBox 496"/>
          <p:cNvSpPr txBox="1"/>
          <p:nvPr/>
        </p:nvSpPr>
        <p:spPr>
          <a:xfrm>
            <a:off x="6018998" y="3252430"/>
            <a:ext cx="1080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i="1" dirty="0"/>
              <a:t>r </a:t>
            </a:r>
            <a:r>
              <a:rPr lang="en-GB" sz="900" dirty="0" smtClean="0"/>
              <a:t>= -0.99</a:t>
            </a:r>
            <a:endParaRPr lang="en-GB" sz="900" dirty="0"/>
          </a:p>
        </p:txBody>
      </p:sp>
      <p:sp>
        <p:nvSpPr>
          <p:cNvPr id="498" name="TextBox 497"/>
          <p:cNvSpPr txBox="1"/>
          <p:nvPr/>
        </p:nvSpPr>
        <p:spPr>
          <a:xfrm>
            <a:off x="6018998" y="1183041"/>
            <a:ext cx="1080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i="1" dirty="0"/>
              <a:t>r</a:t>
            </a:r>
            <a:r>
              <a:rPr lang="el-GR" sz="900" dirty="0" smtClean="0"/>
              <a:t> </a:t>
            </a:r>
            <a:r>
              <a:rPr lang="en-GB" sz="900" dirty="0" smtClean="0"/>
              <a:t>= -0.74</a:t>
            </a:r>
            <a:endParaRPr lang="en-GB" sz="900" dirty="0"/>
          </a:p>
        </p:txBody>
      </p:sp>
      <p:sp>
        <p:nvSpPr>
          <p:cNvPr id="15" name="TextBox 14"/>
          <p:cNvSpPr txBox="1"/>
          <p:nvPr/>
        </p:nvSpPr>
        <p:spPr>
          <a:xfrm>
            <a:off x="1386950" y="5085184"/>
            <a:ext cx="17448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ry Figure </a:t>
            </a:r>
            <a:r>
              <a:rPr lang="en-GB" sz="1200" b="1" dirty="0" smtClean="0"/>
              <a:t>2</a:t>
            </a:r>
            <a:endParaRPr lang="en-GB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683568" y="1052736"/>
            <a:ext cx="323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A</a:t>
            </a:r>
            <a:endParaRPr lang="en-GB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952598" y="1052736"/>
            <a:ext cx="323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B</a:t>
            </a:r>
            <a:endParaRPr lang="en-GB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328862" y="1052736"/>
            <a:ext cx="323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C</a:t>
            </a:r>
            <a:endParaRPr lang="en-GB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413066" y="3063159"/>
            <a:ext cx="323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F</a:t>
            </a:r>
            <a:endParaRPr lang="en-GB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3059832" y="3059848"/>
            <a:ext cx="323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E</a:t>
            </a:r>
            <a:endParaRPr lang="en-GB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683568" y="3060750"/>
            <a:ext cx="323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486871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54</TotalTime>
  <Words>121</Words>
  <Application>Microsoft Macintosh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Prifysgol Bangor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ter Talboys</dc:creator>
  <cp:lastModifiedBy>Bangor University</cp:lastModifiedBy>
  <cp:revision>829</cp:revision>
  <cp:lastPrinted>2013-07-05T12:52:13Z</cp:lastPrinted>
  <dcterms:created xsi:type="dcterms:W3CDTF">2013-04-24T12:16:27Z</dcterms:created>
  <dcterms:modified xsi:type="dcterms:W3CDTF">2015-07-16T07:22:54Z</dcterms:modified>
</cp:coreProperties>
</file>